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56" r:id="rId3"/>
    <p:sldId id="258" r:id="rId4"/>
    <p:sldId id="257" r:id="rId5"/>
    <p:sldId id="259" r:id="rId6"/>
    <p:sldId id="260" r:id="rId7"/>
    <p:sldId id="261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14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828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131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517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497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72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599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80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395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669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224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354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93DD5-28B6-4F81-9B93-94915EF30CEE}" type="datetimeFigureOut">
              <a:rPr lang="en-US" smtClean="0"/>
              <a:t>6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D019A5-B217-4808-8CBD-A38726E9F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09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975A65C-1927-417B-82AD-10C8BB937F79}"/>
              </a:ext>
            </a:extLst>
          </p:cNvPr>
          <p:cNvSpPr txBox="1"/>
          <p:nvPr/>
        </p:nvSpPr>
        <p:spPr>
          <a:xfrm>
            <a:off x="877077" y="1939509"/>
            <a:ext cx="457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latin typeface="Calibri" panose="020F0502020204030204" pitchFamily="34" charset="0"/>
              </a:rPr>
              <a:t>P</a:t>
            </a:r>
            <a:r>
              <a:rPr lang="en-US" altLang="zh-CN" sz="1800" dirty="0">
                <a:solidFill>
                  <a:srgbClr val="000000"/>
                </a:solidFill>
                <a:latin typeface="Calibri" panose="020F0502020204030204" pitchFamily="34" charset="0"/>
              </a:rPr>
              <a:t>lasmid: PMD19T</a:t>
            </a:r>
          </a:p>
          <a:p>
            <a:r>
              <a:rPr lang="en-US" sz="1800" dirty="0">
                <a:solidFill>
                  <a:srgbClr val="000000"/>
                </a:solidFill>
                <a:latin typeface="Calibri" panose="020F0502020204030204" pitchFamily="34" charset="0"/>
              </a:rPr>
              <a:t>Competent cell: E.coli DH5</a:t>
            </a:r>
            <a:r>
              <a:rPr lang="el-GR" sz="1800" dirty="0">
                <a:solidFill>
                  <a:srgbClr val="000000"/>
                </a:solidFill>
                <a:latin typeface="Calibri" panose="020F0502020204030204" pitchFamily="34" charset="0"/>
              </a:rPr>
              <a:t>α</a:t>
            </a:r>
            <a:endParaRPr lang="en-US" sz="1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8887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0B3AAFE-1B74-41AF-9DC9-1C668A79DDA6}"/>
              </a:ext>
            </a:extLst>
          </p:cNvPr>
          <p:cNvSpPr txBox="1"/>
          <p:nvPr/>
        </p:nvSpPr>
        <p:spPr>
          <a:xfrm>
            <a:off x="101653" y="47476"/>
            <a:ext cx="17669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s: </a:t>
            </a:r>
            <a:r>
              <a:rPr lang="en-US" sz="1400" b="1" dirty="0" err="1"/>
              <a:t>Aci_F</a:t>
            </a:r>
            <a:r>
              <a:rPr lang="en-US" sz="1400" b="1" dirty="0"/>
              <a:t>, </a:t>
            </a:r>
            <a:r>
              <a:rPr lang="en-US" sz="1400" b="1" dirty="0" err="1"/>
              <a:t>Aci</a:t>
            </a:r>
            <a:r>
              <a:rPr lang="en-US" sz="1400" b="1" dirty="0"/>
              <a:t> _R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926F84A-4FD4-4790-806A-A97EB860EC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069" y="4120734"/>
            <a:ext cx="5826532" cy="265066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AE183EE-B43B-409A-9BA5-A3B1E7465172}"/>
              </a:ext>
            </a:extLst>
          </p:cNvPr>
          <p:cNvSpPr txBox="1"/>
          <p:nvPr/>
        </p:nvSpPr>
        <p:spPr>
          <a:xfrm>
            <a:off x="2682692" y="348562"/>
            <a:ext cx="974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elt curv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C7C3C2B-193B-4F2D-954D-CB3F9A86A28F}"/>
              </a:ext>
            </a:extLst>
          </p:cNvPr>
          <p:cNvSpPr txBox="1"/>
          <p:nvPr/>
        </p:nvSpPr>
        <p:spPr>
          <a:xfrm>
            <a:off x="101653" y="355253"/>
            <a:ext cx="1487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mplification plo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3C10B7-C142-448E-A02B-7C215FE9A2BF}"/>
              </a:ext>
            </a:extLst>
          </p:cNvPr>
          <p:cNvSpPr txBox="1"/>
          <p:nvPr/>
        </p:nvSpPr>
        <p:spPr>
          <a:xfrm>
            <a:off x="101653" y="3140240"/>
            <a:ext cx="1831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egend: DNA templat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4DAA447-609D-4DC6-84E4-522E828E0F42}"/>
              </a:ext>
            </a:extLst>
          </p:cNvPr>
          <p:cNvSpPr txBox="1"/>
          <p:nvPr/>
        </p:nvSpPr>
        <p:spPr>
          <a:xfrm>
            <a:off x="2619904" y="3133549"/>
            <a:ext cx="2398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genomic DNA of </a:t>
            </a:r>
            <a:r>
              <a:rPr lang="en-US" sz="1400" b="1" dirty="0" err="1"/>
              <a:t>Aci</a:t>
            </a:r>
            <a:endParaRPr lang="en-US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5E6106B-39A3-4219-B60E-504A7225CF68}"/>
              </a:ext>
            </a:extLst>
          </p:cNvPr>
          <p:cNvSpPr txBox="1"/>
          <p:nvPr/>
        </p:nvSpPr>
        <p:spPr>
          <a:xfrm>
            <a:off x="132821" y="3812957"/>
            <a:ext cx="1286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tandard curve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3B7C125F-CEB1-426E-99E6-F57E9DE170E9}"/>
              </a:ext>
            </a:extLst>
          </p:cNvPr>
          <p:cNvCxnSpPr/>
          <p:nvPr/>
        </p:nvCxnSpPr>
        <p:spPr>
          <a:xfrm>
            <a:off x="6233823" y="4675367"/>
            <a:ext cx="0" cy="196397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62AB2DF-6274-4F83-87FE-22FA7A200668}"/>
              </a:ext>
            </a:extLst>
          </p:cNvPr>
          <p:cNvSpPr txBox="1"/>
          <p:nvPr/>
        </p:nvSpPr>
        <p:spPr>
          <a:xfrm>
            <a:off x="6289482" y="5255813"/>
            <a:ext cx="27193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oncentration of DNA template decrease by tenfol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986D33E-08A8-43D6-9CAD-E362814E05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972" y="656339"/>
            <a:ext cx="2229227" cy="24839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83E6815-B88F-4374-98D2-DDBA5A7CB3A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2692" y="656339"/>
            <a:ext cx="2235450" cy="247721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F94A3F8-27E0-42E5-B2BA-CA490E24945F}"/>
              </a:ext>
            </a:extLst>
          </p:cNvPr>
          <p:cNvSpPr txBox="1"/>
          <p:nvPr/>
        </p:nvSpPr>
        <p:spPr>
          <a:xfrm>
            <a:off x="1844909" y="3812957"/>
            <a:ext cx="3296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plasmid containing </a:t>
            </a:r>
            <a:r>
              <a:rPr lang="en-US" sz="1400" dirty="0" err="1"/>
              <a:t>Aci</a:t>
            </a:r>
            <a:r>
              <a:rPr lang="en-US" sz="1400" dirty="0"/>
              <a:t> fragmen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516278-1714-408A-B6CD-F343021F5FAD}"/>
              </a:ext>
            </a:extLst>
          </p:cNvPr>
          <p:cNvSpPr txBox="1"/>
          <p:nvPr/>
        </p:nvSpPr>
        <p:spPr>
          <a:xfrm>
            <a:off x="5039609" y="656339"/>
            <a:ext cx="400273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Aci_F</a:t>
            </a:r>
            <a:r>
              <a:rPr lang="en-US" sz="1600" dirty="0"/>
              <a:t>: </a:t>
            </a:r>
            <a:r>
              <a:rPr lang="en-US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TTTAGTATCTGGTGAAGTCATCCGTA</a:t>
            </a:r>
          </a:p>
          <a:p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Aci_R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: CCGACAAATAAAGCTTGAGTAACTCC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Product length: 92 bp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Target gene:</a:t>
            </a:r>
          </a:p>
          <a:p>
            <a:r>
              <a:rPr lang="en-US" sz="1600" dirty="0"/>
              <a:t>&gt;lcl|NZ_CP046536.1_cds_WP_000428564.1_58 [</a:t>
            </a:r>
            <a:r>
              <a:rPr lang="en-US" sz="1600" dirty="0" err="1"/>
              <a:t>locus_tag</a:t>
            </a:r>
            <a:r>
              <a:rPr lang="en-US" sz="1600" dirty="0"/>
              <a:t>=GOD87_RS00290] [protein=DUF1003 domain-containing protein] [</a:t>
            </a:r>
            <a:r>
              <a:rPr lang="en-US" sz="1600" dirty="0" err="1"/>
              <a:t>protein_id</a:t>
            </a:r>
            <a:r>
              <a:rPr lang="en-US" sz="1600" dirty="0"/>
              <a:t>=WP_000428564.1] [location=61045..61746] [</a:t>
            </a:r>
            <a:r>
              <a:rPr lang="en-US" sz="1600" dirty="0" err="1"/>
              <a:t>gbkey</a:t>
            </a:r>
            <a:r>
              <a:rPr lang="en-US" sz="1600" dirty="0"/>
              <a:t>=CDS]</a:t>
            </a:r>
          </a:p>
          <a:p>
            <a:r>
              <a:rPr lang="en-US" sz="1600" dirty="0"/>
              <a:t>Standard curve:</a:t>
            </a:r>
          </a:p>
          <a:p>
            <a:r>
              <a:rPr lang="pl-PL" sz="1600" dirty="0"/>
              <a:t>lg[DNA copies]/ul=-0.2906*CT+11.94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7049823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C274C62-E84B-45E3-8D22-53DB732B375A}"/>
              </a:ext>
            </a:extLst>
          </p:cNvPr>
          <p:cNvSpPr txBox="1"/>
          <p:nvPr/>
        </p:nvSpPr>
        <p:spPr>
          <a:xfrm>
            <a:off x="101653" y="47476"/>
            <a:ext cx="19561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s: </a:t>
            </a:r>
            <a:r>
              <a:rPr lang="en-US" sz="1400" b="1" dirty="0" err="1"/>
              <a:t>Com_F</a:t>
            </a:r>
            <a:r>
              <a:rPr lang="en-US" sz="1400" b="1" dirty="0"/>
              <a:t>, </a:t>
            </a:r>
            <a:r>
              <a:rPr lang="en-US" sz="1400" b="1" dirty="0" err="1"/>
              <a:t>Com_R</a:t>
            </a:r>
            <a:endParaRPr lang="en-US" sz="14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EA6555A-3C26-479E-8A6A-A6BE55BF217E}"/>
              </a:ext>
            </a:extLst>
          </p:cNvPr>
          <p:cNvSpPr txBox="1"/>
          <p:nvPr/>
        </p:nvSpPr>
        <p:spPr>
          <a:xfrm>
            <a:off x="3360351" y="355253"/>
            <a:ext cx="974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elt curv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96CF096-8279-4C71-A42B-2520FED5695D}"/>
              </a:ext>
            </a:extLst>
          </p:cNvPr>
          <p:cNvSpPr txBox="1"/>
          <p:nvPr/>
        </p:nvSpPr>
        <p:spPr>
          <a:xfrm>
            <a:off x="101653" y="355253"/>
            <a:ext cx="1487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mplification plo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261F20E-D512-409D-B9E8-C3F412E4877E}"/>
              </a:ext>
            </a:extLst>
          </p:cNvPr>
          <p:cNvSpPr txBox="1"/>
          <p:nvPr/>
        </p:nvSpPr>
        <p:spPr>
          <a:xfrm>
            <a:off x="101653" y="3140240"/>
            <a:ext cx="1831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egend: DNA templat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0928A7-12EB-4197-B428-8C34AF0C949B}"/>
              </a:ext>
            </a:extLst>
          </p:cNvPr>
          <p:cNvSpPr txBox="1"/>
          <p:nvPr/>
        </p:nvSpPr>
        <p:spPr>
          <a:xfrm>
            <a:off x="2879078" y="3140240"/>
            <a:ext cx="25024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genomic DNA of </a:t>
            </a:r>
            <a:r>
              <a:rPr lang="en-US" sz="1400" b="1" dirty="0"/>
              <a:t>Com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774374-B550-4B1C-97B9-74C36398C51A}"/>
              </a:ext>
            </a:extLst>
          </p:cNvPr>
          <p:cNvSpPr txBox="1"/>
          <p:nvPr/>
        </p:nvSpPr>
        <p:spPr>
          <a:xfrm>
            <a:off x="132821" y="3812957"/>
            <a:ext cx="1286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tandard curv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9ED8721-31F1-4B4E-99FD-68C79D55B63D}"/>
              </a:ext>
            </a:extLst>
          </p:cNvPr>
          <p:cNvCxnSpPr>
            <a:cxnSpLocks/>
          </p:cNvCxnSpPr>
          <p:nvPr/>
        </p:nvCxnSpPr>
        <p:spPr>
          <a:xfrm>
            <a:off x="6384743" y="5154761"/>
            <a:ext cx="224435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9CA05B4-2F27-42EA-8221-30ED8A6769B9}"/>
              </a:ext>
            </a:extLst>
          </p:cNvPr>
          <p:cNvSpPr txBox="1"/>
          <p:nvPr/>
        </p:nvSpPr>
        <p:spPr>
          <a:xfrm>
            <a:off x="6289482" y="5255813"/>
            <a:ext cx="27193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oncentration of DNA template decrease by tenfold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E87090E-D13D-470D-8594-C670085ACA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785" y="4120734"/>
            <a:ext cx="5804450" cy="263359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9D0C0F9-CEB2-4B76-A233-AB440F2EDD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21" y="690477"/>
            <a:ext cx="2600884" cy="242231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890954F-825B-4E46-82A5-E38EFDB3BD6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8541" y="690477"/>
            <a:ext cx="2203490" cy="244976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9440351F-78E9-43CA-96C3-12489E1C7E7B}"/>
              </a:ext>
            </a:extLst>
          </p:cNvPr>
          <p:cNvSpPr txBox="1"/>
          <p:nvPr/>
        </p:nvSpPr>
        <p:spPr>
          <a:xfrm>
            <a:off x="1844909" y="3812957"/>
            <a:ext cx="3408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plasmid containing </a:t>
            </a:r>
            <a:r>
              <a:rPr lang="en-US" sz="1400" b="1" dirty="0"/>
              <a:t>Com</a:t>
            </a:r>
            <a:r>
              <a:rPr lang="en-US" sz="1400" dirty="0"/>
              <a:t> fragmen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11D6D81-45E2-4CE2-A0CC-3768A5DF5ADA}"/>
              </a:ext>
            </a:extLst>
          </p:cNvPr>
          <p:cNvSpPr txBox="1"/>
          <p:nvPr/>
        </p:nvSpPr>
        <p:spPr>
          <a:xfrm>
            <a:off x="5232031" y="647250"/>
            <a:ext cx="400273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Com_F</a:t>
            </a:r>
            <a:r>
              <a:rPr lang="en-US" sz="1600" dirty="0"/>
              <a:t>: CTCAAAACCAGTGTGATCGTGGAA </a:t>
            </a:r>
          </a:p>
          <a:p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Com_R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: TATTGCCCATCAGCAGAGTGTAGC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Product length: 109 bp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Target gene: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&gt;lcl|NZ_CP083451.1_cds_WP_224152861.1_192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locus_tag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LAD35_RS00960] [protein=tripartite tricarboxylate transporter substrate binding protein]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protein_id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WP_224152861.1]</a:t>
            </a:r>
          </a:p>
          <a:p>
            <a:r>
              <a:rPr lang="en-US" sz="1600" dirty="0"/>
              <a:t>Standard curve:</a:t>
            </a:r>
          </a:p>
          <a:p>
            <a:r>
              <a:rPr lang="pl-PL" sz="1600" dirty="0">
                <a:solidFill>
                  <a:srgbClr val="000000"/>
                </a:solidFill>
                <a:latin typeface="Calibri" panose="020F0502020204030204" pitchFamily="34" charset="0"/>
              </a:rPr>
              <a:t>lg[DNA copies]/ul=-0.2799*CT+12.5295 </a:t>
            </a:r>
            <a:endParaRPr lang="en-US" sz="16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88301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0E6C65D-18BE-423C-90D7-E545C9961F54}"/>
              </a:ext>
            </a:extLst>
          </p:cNvPr>
          <p:cNvSpPr txBox="1"/>
          <p:nvPr/>
        </p:nvSpPr>
        <p:spPr>
          <a:xfrm>
            <a:off x="101653" y="47476"/>
            <a:ext cx="1792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s: </a:t>
            </a:r>
            <a:r>
              <a:rPr lang="en-US" sz="1400" b="1" dirty="0" err="1"/>
              <a:t>Chr_F</a:t>
            </a:r>
            <a:r>
              <a:rPr lang="en-US" sz="1400" b="1" dirty="0"/>
              <a:t>, </a:t>
            </a:r>
            <a:r>
              <a:rPr lang="en-US" sz="1400" b="1" dirty="0" err="1"/>
              <a:t>Chr_R</a:t>
            </a:r>
            <a:endParaRPr lang="en-US" sz="14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332E0B0-4EA9-44AB-82F1-4CB15DFBA859}"/>
              </a:ext>
            </a:extLst>
          </p:cNvPr>
          <p:cNvSpPr txBox="1"/>
          <p:nvPr/>
        </p:nvSpPr>
        <p:spPr>
          <a:xfrm>
            <a:off x="3360351" y="355253"/>
            <a:ext cx="974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elt curv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DDC0E2F-2217-47ED-8D53-33A8A69C6B43}"/>
              </a:ext>
            </a:extLst>
          </p:cNvPr>
          <p:cNvSpPr txBox="1"/>
          <p:nvPr/>
        </p:nvSpPr>
        <p:spPr>
          <a:xfrm>
            <a:off x="101653" y="355253"/>
            <a:ext cx="1487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mplification plo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7699514-9AE5-482E-A534-55C6D02BA15C}"/>
              </a:ext>
            </a:extLst>
          </p:cNvPr>
          <p:cNvSpPr txBox="1"/>
          <p:nvPr/>
        </p:nvSpPr>
        <p:spPr>
          <a:xfrm>
            <a:off x="101653" y="3140240"/>
            <a:ext cx="1831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egend: DNA templat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AC78AA2-E41F-4842-9C5A-097E2BE200AF}"/>
              </a:ext>
            </a:extLst>
          </p:cNvPr>
          <p:cNvSpPr txBox="1"/>
          <p:nvPr/>
        </p:nvSpPr>
        <p:spPr>
          <a:xfrm>
            <a:off x="2854519" y="3140240"/>
            <a:ext cx="2422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genomic DNA of </a:t>
            </a:r>
            <a:r>
              <a:rPr lang="en-US" sz="1400" b="1" dirty="0"/>
              <a:t>Ch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FD0B318-9C76-4B2A-AAEA-7C8E508E35E3}"/>
              </a:ext>
            </a:extLst>
          </p:cNvPr>
          <p:cNvSpPr txBox="1"/>
          <p:nvPr/>
        </p:nvSpPr>
        <p:spPr>
          <a:xfrm>
            <a:off x="132821" y="3812957"/>
            <a:ext cx="1286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tandard curv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205549F7-C212-454A-8456-3FAC28D76CCA}"/>
              </a:ext>
            </a:extLst>
          </p:cNvPr>
          <p:cNvCxnSpPr>
            <a:cxnSpLocks/>
          </p:cNvCxnSpPr>
          <p:nvPr/>
        </p:nvCxnSpPr>
        <p:spPr>
          <a:xfrm>
            <a:off x="6358111" y="5030474"/>
            <a:ext cx="222659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6744476-C484-4569-87C4-F39568B839CA}"/>
              </a:ext>
            </a:extLst>
          </p:cNvPr>
          <p:cNvSpPr txBox="1"/>
          <p:nvPr/>
        </p:nvSpPr>
        <p:spPr>
          <a:xfrm>
            <a:off x="6289482" y="5255813"/>
            <a:ext cx="27193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oncentration of DNA template decrease by tenfold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4F1D3FCC-6105-4C5C-A39B-836B2D4701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588" y="4120734"/>
            <a:ext cx="5701085" cy="259831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18748EB-F8E4-48AC-BE41-826A89209F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618" y="716730"/>
            <a:ext cx="2127479" cy="236981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AD8D666-1403-47F0-94ED-ED6E8251A2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4519" y="729057"/>
            <a:ext cx="2124568" cy="235748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7EF9AD9-3BD7-4873-A4DD-10E24970CEAB}"/>
              </a:ext>
            </a:extLst>
          </p:cNvPr>
          <p:cNvSpPr txBox="1"/>
          <p:nvPr/>
        </p:nvSpPr>
        <p:spPr>
          <a:xfrm>
            <a:off x="1844909" y="3812957"/>
            <a:ext cx="33300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plasmid containing </a:t>
            </a:r>
            <a:r>
              <a:rPr lang="en-US" sz="1400" b="1" dirty="0"/>
              <a:t>Chr </a:t>
            </a:r>
            <a:r>
              <a:rPr lang="en-US" sz="1400" dirty="0"/>
              <a:t>fragmen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AE086FF-2C27-49B2-B295-328A0942F79C}"/>
              </a:ext>
            </a:extLst>
          </p:cNvPr>
          <p:cNvSpPr txBox="1"/>
          <p:nvPr/>
        </p:nvSpPr>
        <p:spPr>
          <a:xfrm>
            <a:off x="5174923" y="520347"/>
            <a:ext cx="400273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rimer information:</a:t>
            </a:r>
          </a:p>
          <a:p>
            <a:r>
              <a:rPr lang="en-US" sz="1600" dirty="0" err="1"/>
              <a:t>Chr_F</a:t>
            </a:r>
            <a:r>
              <a:rPr lang="en-US" sz="1600" dirty="0"/>
              <a:t>: </a:t>
            </a:r>
            <a:r>
              <a:rPr lang="en-US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GAACATCAGTTATCTTGTGAGCGGTA</a:t>
            </a:r>
          </a:p>
          <a:p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Chr_R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: CATACAGGCTCCCATTCCTATTGTG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Product length: 94 bp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Target gene:</a:t>
            </a:r>
          </a:p>
          <a:p>
            <a:r>
              <a:rPr lang="en-US" sz="1600" dirty="0"/>
              <a:t>&gt;lcl|NZ_CP084347.1_cds_WP_225717821.1_11 [</a:t>
            </a:r>
            <a:r>
              <a:rPr lang="en-US" sz="1600" dirty="0" err="1"/>
              <a:t>locus_tag</a:t>
            </a:r>
            <a:r>
              <a:rPr lang="en-US" sz="1600" dirty="0"/>
              <a:t>=KB553_RS00055] [protein=MFS transporter] [</a:t>
            </a:r>
            <a:r>
              <a:rPr lang="en-US" sz="1600" dirty="0" err="1"/>
              <a:t>protein_id</a:t>
            </a:r>
            <a:r>
              <a:rPr lang="en-US" sz="1600" dirty="0"/>
              <a:t>=WP_225717821.1] [location=9574..11166] [</a:t>
            </a:r>
            <a:r>
              <a:rPr lang="en-US" sz="1600" dirty="0" err="1"/>
              <a:t>gbkey</a:t>
            </a:r>
            <a:r>
              <a:rPr lang="en-US" sz="1600" dirty="0"/>
              <a:t>=CDS]</a:t>
            </a:r>
          </a:p>
          <a:p>
            <a:r>
              <a:rPr lang="en-US" sz="1600" dirty="0"/>
              <a:t>Standard curve:</a:t>
            </a:r>
          </a:p>
          <a:p>
            <a:r>
              <a:rPr lang="pl-PL" sz="1600" dirty="0"/>
              <a:t>lg[DNA copies]/ul=-0.2962*CT+12.480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8511080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80EA9FE-17E6-43BA-B005-CF2527611FB4}"/>
              </a:ext>
            </a:extLst>
          </p:cNvPr>
          <p:cNvSpPr txBox="1"/>
          <p:nvPr/>
        </p:nvSpPr>
        <p:spPr>
          <a:xfrm>
            <a:off x="101653" y="47476"/>
            <a:ext cx="17732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s: </a:t>
            </a:r>
            <a:r>
              <a:rPr lang="en-US" sz="1400" b="1" dirty="0" err="1"/>
              <a:t>Ent_F</a:t>
            </a:r>
            <a:r>
              <a:rPr lang="en-US" sz="1400" b="1" dirty="0"/>
              <a:t>, </a:t>
            </a:r>
            <a:r>
              <a:rPr lang="en-US" sz="1400" b="1" dirty="0" err="1"/>
              <a:t>Ent_R</a:t>
            </a:r>
            <a:endParaRPr lang="en-US" sz="14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9EA61FA-ADD3-47CA-BA43-78333C177EF1}"/>
              </a:ext>
            </a:extLst>
          </p:cNvPr>
          <p:cNvSpPr txBox="1"/>
          <p:nvPr/>
        </p:nvSpPr>
        <p:spPr>
          <a:xfrm>
            <a:off x="2996457" y="336236"/>
            <a:ext cx="974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elt curv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8D823F5-2EA9-44E6-9954-93281F3A7B39}"/>
              </a:ext>
            </a:extLst>
          </p:cNvPr>
          <p:cNvSpPr txBox="1"/>
          <p:nvPr/>
        </p:nvSpPr>
        <p:spPr>
          <a:xfrm>
            <a:off x="101653" y="355253"/>
            <a:ext cx="1487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mplification plo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B02DBFE-620A-4EED-86DC-E21CBF0E6435}"/>
              </a:ext>
            </a:extLst>
          </p:cNvPr>
          <p:cNvSpPr txBox="1"/>
          <p:nvPr/>
        </p:nvSpPr>
        <p:spPr>
          <a:xfrm>
            <a:off x="101653" y="3140240"/>
            <a:ext cx="1831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egend: DNA templat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7C361B4-A92D-46A7-8223-88178B99078F}"/>
              </a:ext>
            </a:extLst>
          </p:cNvPr>
          <p:cNvSpPr txBox="1"/>
          <p:nvPr/>
        </p:nvSpPr>
        <p:spPr>
          <a:xfrm>
            <a:off x="2933669" y="3121223"/>
            <a:ext cx="2451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genomic DNA of </a:t>
            </a:r>
            <a:r>
              <a:rPr lang="en-US" sz="1400" b="1" dirty="0"/>
              <a:t>E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D9A2AE-E3A1-4CA3-B7EF-991F254212AD}"/>
              </a:ext>
            </a:extLst>
          </p:cNvPr>
          <p:cNvSpPr txBox="1"/>
          <p:nvPr/>
        </p:nvSpPr>
        <p:spPr>
          <a:xfrm>
            <a:off x="132821" y="3812957"/>
            <a:ext cx="1286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tandard curv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09C78403-B257-466F-B69A-C5C760F0A88C}"/>
              </a:ext>
            </a:extLst>
          </p:cNvPr>
          <p:cNvCxnSpPr>
            <a:cxnSpLocks/>
          </p:cNvCxnSpPr>
          <p:nvPr/>
        </p:nvCxnSpPr>
        <p:spPr>
          <a:xfrm>
            <a:off x="6289482" y="5128129"/>
            <a:ext cx="226210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1FF6B8FA-53F3-44AF-B72C-2A0321094EC2}"/>
              </a:ext>
            </a:extLst>
          </p:cNvPr>
          <p:cNvSpPr txBox="1"/>
          <p:nvPr/>
        </p:nvSpPr>
        <p:spPr>
          <a:xfrm>
            <a:off x="6289482" y="5255813"/>
            <a:ext cx="27193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oncentration of DNA template decrease by tenfold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DA3763E-A777-42AB-AB43-ED369546DF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21" y="4120734"/>
            <a:ext cx="5916822" cy="268979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AFC5047-8F12-460B-94F1-BF780079E9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21" y="596138"/>
            <a:ext cx="2699031" cy="254410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5D136C7-27E2-477C-843F-578E99DD348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6457" y="577121"/>
            <a:ext cx="2301164" cy="254410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87E8DBB-2DB5-4DD2-A127-BE1DE5B0D8A4}"/>
              </a:ext>
            </a:extLst>
          </p:cNvPr>
          <p:cNvSpPr txBox="1"/>
          <p:nvPr/>
        </p:nvSpPr>
        <p:spPr>
          <a:xfrm>
            <a:off x="1844909" y="3812957"/>
            <a:ext cx="3317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plasmid containing </a:t>
            </a:r>
            <a:r>
              <a:rPr lang="en-US" sz="1400" b="1" dirty="0"/>
              <a:t>Ent</a:t>
            </a:r>
            <a:r>
              <a:rPr lang="en-US" sz="1400" dirty="0"/>
              <a:t> fragmen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FEE2EAE-88D6-4BD6-82CE-415799DF3C03}"/>
              </a:ext>
            </a:extLst>
          </p:cNvPr>
          <p:cNvSpPr txBox="1"/>
          <p:nvPr/>
        </p:nvSpPr>
        <p:spPr>
          <a:xfrm>
            <a:off x="5225622" y="509141"/>
            <a:ext cx="400273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Ent_F</a:t>
            </a:r>
            <a:r>
              <a:rPr lang="en-US" sz="1600" dirty="0"/>
              <a:t>: AGCGTTACAGCAGCTACAGGATATTCACC</a:t>
            </a:r>
          </a:p>
          <a:p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Ent_R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: CTTTTCACCATCACCCCATCCCTCGGTA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Product length: 95 bp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Target gene: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&gt;lcl|NZ_CP083403.1_cds_80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locus_tag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K9O83_RS00400] [protein=class I SAM-dependent methyltransferase] [pseudo=true] [partial=5'] [location=&lt;76927..77040]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gbkey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CDS]</a:t>
            </a:r>
          </a:p>
          <a:p>
            <a:r>
              <a:rPr lang="en-US" sz="1600" dirty="0"/>
              <a:t>Standard curve:</a:t>
            </a:r>
          </a:p>
          <a:p>
            <a:r>
              <a:rPr lang="pl-PL" sz="1600" dirty="0">
                <a:solidFill>
                  <a:srgbClr val="000000"/>
                </a:solidFill>
                <a:latin typeface="Calibri" panose="020F0502020204030204" pitchFamily="34" charset="0"/>
              </a:rPr>
              <a:t>lg[DNA copies]/ul=-0.3028*CT+12.5307</a:t>
            </a:r>
            <a:endParaRPr lang="en-US" sz="16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76955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782D8C7-11A6-42F6-AE71-F6464C6C0F22}"/>
              </a:ext>
            </a:extLst>
          </p:cNvPr>
          <p:cNvSpPr txBox="1"/>
          <p:nvPr/>
        </p:nvSpPr>
        <p:spPr>
          <a:xfrm>
            <a:off x="101653" y="47476"/>
            <a:ext cx="1836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s: </a:t>
            </a:r>
            <a:r>
              <a:rPr lang="en-US" sz="1400" b="1" dirty="0" err="1"/>
              <a:t>Pan_F</a:t>
            </a:r>
            <a:r>
              <a:rPr lang="en-US" sz="1400" b="1" dirty="0"/>
              <a:t>, </a:t>
            </a:r>
            <a:r>
              <a:rPr lang="en-US" sz="1400" b="1" dirty="0" err="1"/>
              <a:t>Pan_R</a:t>
            </a:r>
            <a:endParaRPr lang="en-US" sz="14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152E7FE-7609-4FA3-B5D3-8A177F5FC71C}"/>
              </a:ext>
            </a:extLst>
          </p:cNvPr>
          <p:cNvSpPr txBox="1"/>
          <p:nvPr/>
        </p:nvSpPr>
        <p:spPr>
          <a:xfrm>
            <a:off x="3360351" y="355253"/>
            <a:ext cx="974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elt curv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B967B53-BCD0-45A8-9BC8-E4244D9C99FF}"/>
              </a:ext>
            </a:extLst>
          </p:cNvPr>
          <p:cNvSpPr txBox="1"/>
          <p:nvPr/>
        </p:nvSpPr>
        <p:spPr>
          <a:xfrm>
            <a:off x="101653" y="355253"/>
            <a:ext cx="1487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mplification plo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01D2C1B-641B-432B-8F1E-582DEDCD34FE}"/>
              </a:ext>
            </a:extLst>
          </p:cNvPr>
          <p:cNvSpPr txBox="1"/>
          <p:nvPr/>
        </p:nvSpPr>
        <p:spPr>
          <a:xfrm>
            <a:off x="101653" y="3140240"/>
            <a:ext cx="1831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egend: DNA templat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EA62D88-07BD-4688-AD72-61931ECD7866}"/>
              </a:ext>
            </a:extLst>
          </p:cNvPr>
          <p:cNvSpPr txBox="1"/>
          <p:nvPr/>
        </p:nvSpPr>
        <p:spPr>
          <a:xfrm>
            <a:off x="3045046" y="3138310"/>
            <a:ext cx="2439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genomic DNA of </a:t>
            </a:r>
            <a:r>
              <a:rPr lang="en-US" sz="1400" b="1" dirty="0"/>
              <a:t>Pa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E97517-94DE-4D6A-B6EA-2EC70DF18341}"/>
              </a:ext>
            </a:extLst>
          </p:cNvPr>
          <p:cNvSpPr txBox="1"/>
          <p:nvPr/>
        </p:nvSpPr>
        <p:spPr>
          <a:xfrm>
            <a:off x="132821" y="3812957"/>
            <a:ext cx="1286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tandard curv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A3546C2-9A54-4EA8-828A-2F0A82222F68}"/>
              </a:ext>
            </a:extLst>
          </p:cNvPr>
          <p:cNvCxnSpPr>
            <a:cxnSpLocks/>
          </p:cNvCxnSpPr>
          <p:nvPr/>
        </p:nvCxnSpPr>
        <p:spPr>
          <a:xfrm>
            <a:off x="6429132" y="5234893"/>
            <a:ext cx="232425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121F43CA-01DD-450B-AA6D-ED4CFCAB15B4}"/>
              </a:ext>
            </a:extLst>
          </p:cNvPr>
          <p:cNvSpPr txBox="1"/>
          <p:nvPr/>
        </p:nvSpPr>
        <p:spPr>
          <a:xfrm>
            <a:off x="6289482" y="5255813"/>
            <a:ext cx="27193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oncentration of DNA template decrease by tenfold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0B42F7D-86EB-408A-A4C7-3B573CA139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350" y="4120734"/>
            <a:ext cx="5908953" cy="268979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42C66B5-2835-4924-BE5F-2894FCAA5F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21" y="664961"/>
            <a:ext cx="2640035" cy="247527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ECC6AF1-E6ED-4143-A76C-ADF1E130FB2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3816" y="663030"/>
            <a:ext cx="2222834" cy="247528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7B92362-4431-45ED-BADA-A93537A354AE}"/>
              </a:ext>
            </a:extLst>
          </p:cNvPr>
          <p:cNvSpPr txBox="1"/>
          <p:nvPr/>
        </p:nvSpPr>
        <p:spPr>
          <a:xfrm>
            <a:off x="1844909" y="3812957"/>
            <a:ext cx="3345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plasmid containing </a:t>
            </a:r>
            <a:r>
              <a:rPr lang="en-US" sz="1400" b="1" dirty="0"/>
              <a:t>Pan</a:t>
            </a:r>
            <a:r>
              <a:rPr lang="en-US" sz="1400" dirty="0"/>
              <a:t> fragmen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AA0E596-4930-4A3D-86B8-70F07D3074B1}"/>
              </a:ext>
            </a:extLst>
          </p:cNvPr>
          <p:cNvSpPr txBox="1"/>
          <p:nvPr/>
        </p:nvSpPr>
        <p:spPr>
          <a:xfrm>
            <a:off x="5446650" y="645320"/>
            <a:ext cx="3781326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Pan_F</a:t>
            </a:r>
            <a:r>
              <a:rPr lang="en-US" sz="1600" dirty="0"/>
              <a:t>: TTAACATCGAAAAGCCTTCCCACCGTA</a:t>
            </a:r>
          </a:p>
          <a:p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Pan_R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: ATTCATCAGAAGCGCATGTATTACACT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Product length: 101 bp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Target gene: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&gt;lcl|NZ_CP083448.1_cds_WP_039382012.1_226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locus_tag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LAC65_RS01220] [protein=hypothetical protein]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protein_id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WP_039382012.1] [location=272583..273698]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gbkey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CDS]</a:t>
            </a:r>
          </a:p>
          <a:p>
            <a:r>
              <a:rPr lang="en-US" sz="1600" dirty="0"/>
              <a:t>Standard curve:</a:t>
            </a:r>
          </a:p>
          <a:p>
            <a:r>
              <a:rPr lang="pl-PL" sz="1600" dirty="0">
                <a:solidFill>
                  <a:srgbClr val="000000"/>
                </a:solidFill>
                <a:latin typeface="Calibri" panose="020F0502020204030204" pitchFamily="34" charset="0"/>
              </a:rPr>
              <a:t>lg[DNA copies]/ul=-0.3149*CT+12.9605</a:t>
            </a:r>
            <a:endParaRPr lang="en-US" sz="16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2298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8EEE57F-4DB1-451C-A42C-CDF40D031A78}"/>
              </a:ext>
            </a:extLst>
          </p:cNvPr>
          <p:cNvSpPr txBox="1"/>
          <p:nvPr/>
        </p:nvSpPr>
        <p:spPr>
          <a:xfrm>
            <a:off x="101653" y="47476"/>
            <a:ext cx="1795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s: </a:t>
            </a:r>
            <a:r>
              <a:rPr lang="en-US" sz="1400" b="1" dirty="0" err="1"/>
              <a:t>Pse_F</a:t>
            </a:r>
            <a:r>
              <a:rPr lang="en-US" sz="1400" b="1" dirty="0"/>
              <a:t>, </a:t>
            </a:r>
            <a:r>
              <a:rPr lang="en-US" sz="1400" b="1" dirty="0" err="1"/>
              <a:t>Pse_R</a:t>
            </a:r>
            <a:endParaRPr lang="en-US" sz="14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96CFF07-4F30-417E-9C2D-7BF0A99F091A}"/>
              </a:ext>
            </a:extLst>
          </p:cNvPr>
          <p:cNvSpPr txBox="1"/>
          <p:nvPr/>
        </p:nvSpPr>
        <p:spPr>
          <a:xfrm>
            <a:off x="2859105" y="355253"/>
            <a:ext cx="974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elt curv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AC8F82-5577-4A39-ADD9-35E48651C42F}"/>
              </a:ext>
            </a:extLst>
          </p:cNvPr>
          <p:cNvSpPr txBox="1"/>
          <p:nvPr/>
        </p:nvSpPr>
        <p:spPr>
          <a:xfrm>
            <a:off x="101653" y="355253"/>
            <a:ext cx="1487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mplification plo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9B2C06-892D-4FEF-9A17-C9437B9221B1}"/>
              </a:ext>
            </a:extLst>
          </p:cNvPr>
          <p:cNvSpPr txBox="1"/>
          <p:nvPr/>
        </p:nvSpPr>
        <p:spPr>
          <a:xfrm>
            <a:off x="101653" y="3140240"/>
            <a:ext cx="1831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egend: DNA templat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B8FE95-414A-4909-9078-5925DA36E419}"/>
              </a:ext>
            </a:extLst>
          </p:cNvPr>
          <p:cNvSpPr txBox="1"/>
          <p:nvPr/>
        </p:nvSpPr>
        <p:spPr>
          <a:xfrm>
            <a:off x="2796317" y="3140240"/>
            <a:ext cx="2419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plate: genomic DNA of </a:t>
            </a:r>
            <a:r>
              <a:rPr lang="en-US" sz="1400" b="1" dirty="0" err="1"/>
              <a:t>Pse</a:t>
            </a:r>
            <a:endParaRPr lang="en-US" sz="1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F6B2B8B-DF7C-44C0-9F19-9B61B45DA38E}"/>
              </a:ext>
            </a:extLst>
          </p:cNvPr>
          <p:cNvSpPr txBox="1"/>
          <p:nvPr/>
        </p:nvSpPr>
        <p:spPr>
          <a:xfrm>
            <a:off x="132821" y="3812957"/>
            <a:ext cx="1286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tandard curv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B6A5F287-1108-4DFA-B5A9-2AF2F69E02DC}"/>
              </a:ext>
            </a:extLst>
          </p:cNvPr>
          <p:cNvCxnSpPr>
            <a:cxnSpLocks/>
          </p:cNvCxnSpPr>
          <p:nvPr/>
        </p:nvCxnSpPr>
        <p:spPr>
          <a:xfrm>
            <a:off x="6402499" y="5226015"/>
            <a:ext cx="236863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BFD49C97-43E1-47C4-9749-475D84087F5A}"/>
              </a:ext>
            </a:extLst>
          </p:cNvPr>
          <p:cNvSpPr txBox="1"/>
          <p:nvPr/>
        </p:nvSpPr>
        <p:spPr>
          <a:xfrm>
            <a:off x="6289482" y="5255813"/>
            <a:ext cx="27193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oncentration of DNA template decrease by tenfol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3E5B6A6-178C-4CAF-8F81-453D15B665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21" y="4099183"/>
            <a:ext cx="5956297" cy="271134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BD230E5-BD2A-46A1-B19F-89AD5F6473B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9105" y="663031"/>
            <a:ext cx="2214826" cy="247577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965E1AE-415B-4ABD-B4F5-07EC4305371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22" y="636082"/>
            <a:ext cx="2248156" cy="2502727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D2D2400F-B93F-45A1-A118-83982B132488}"/>
              </a:ext>
            </a:extLst>
          </p:cNvPr>
          <p:cNvSpPr txBox="1"/>
          <p:nvPr/>
        </p:nvSpPr>
        <p:spPr>
          <a:xfrm>
            <a:off x="5136719" y="824417"/>
            <a:ext cx="3706696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Pse_F</a:t>
            </a:r>
            <a:r>
              <a:rPr lang="en-US" sz="1600" dirty="0"/>
              <a:t>: GAAATTCATCTTCGAACACAGCACAC</a:t>
            </a:r>
          </a:p>
          <a:p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Pse_R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: CTAGCTAACGGGGTTAAGTGCTTC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Product length: 124 bp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Target gene:</a:t>
            </a:r>
          </a:p>
          <a:p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&gt;lcl|NZ_CP046538.1_cds_WP_156714731.1_565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locus_tag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GOM96_RS02845] [protein=efflux RND transporter permease subunit]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protein_id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WP_156714731.1] [location=646415..648859] [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gbkey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=CDS]</a:t>
            </a:r>
          </a:p>
          <a:p>
            <a:r>
              <a:rPr lang="en-US" sz="1600" dirty="0"/>
              <a:t>Standard curve:</a:t>
            </a:r>
          </a:p>
          <a:p>
            <a:r>
              <a:rPr lang="pl-PL" sz="1600" dirty="0">
                <a:solidFill>
                  <a:srgbClr val="000000"/>
                </a:solidFill>
                <a:latin typeface="Calibri" panose="020F0502020204030204" pitchFamily="34" charset="0"/>
              </a:rPr>
              <a:t>lg[DNA copies]/ul=-0.2812*CT+12.2596</a:t>
            </a:r>
            <a:endParaRPr lang="en-US" sz="16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5605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719</Words>
  <Application>Microsoft Office PowerPoint</Application>
  <PresentationFormat>On-screen Show (4:3)</PresentationFormat>
  <Paragraphs>9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 Xinli</dc:creator>
  <cp:lastModifiedBy>Sun Xinli</cp:lastModifiedBy>
  <cp:revision>6</cp:revision>
  <dcterms:created xsi:type="dcterms:W3CDTF">2022-05-25T02:42:48Z</dcterms:created>
  <dcterms:modified xsi:type="dcterms:W3CDTF">2022-06-15T03:17:15Z</dcterms:modified>
</cp:coreProperties>
</file>